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720907" y="92125"/>
            <a:ext cx="97206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2 Table: Muscular dystrophy and congenital </a:t>
            </a:r>
            <a:r>
              <a:rPr lang="en-IN" b="1" dirty="0" err="1" smtClean="0">
                <a:latin typeface="Times New Roman" pitchFamily="18" charset="0"/>
                <a:cs typeface="Times New Roman" pitchFamily="18" charset="0"/>
              </a:rPr>
              <a:t>myopathy</a:t>
            </a:r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 gene panel for NGS analysis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737228"/>
              </p:ext>
            </p:extLst>
          </p:nvPr>
        </p:nvGraphicFramePr>
        <p:xfrm>
          <a:off x="2271033" y="600795"/>
          <a:ext cx="7369356" cy="6130936"/>
        </p:xfrm>
        <a:graphic>
          <a:graphicData uri="http://schemas.openxmlformats.org/drawingml/2006/table">
            <a:tbl>
              <a:tblPr/>
              <a:tblGrid>
                <a:gridCol w="906915">
                  <a:extLst>
                    <a:ext uri="{9D8B030D-6E8A-4147-A177-3AD203B41FA5}">
                      <a16:colId xmlns:a16="http://schemas.microsoft.com/office/drawing/2014/main" val="2216532643"/>
                    </a:ext>
                  </a:extLst>
                </a:gridCol>
                <a:gridCol w="1212949">
                  <a:extLst>
                    <a:ext uri="{9D8B030D-6E8A-4147-A177-3AD203B41FA5}">
                      <a16:colId xmlns:a16="http://schemas.microsoft.com/office/drawing/2014/main" val="3908178503"/>
                    </a:ext>
                  </a:extLst>
                </a:gridCol>
                <a:gridCol w="1203008">
                  <a:extLst>
                    <a:ext uri="{9D8B030D-6E8A-4147-A177-3AD203B41FA5}">
                      <a16:colId xmlns:a16="http://schemas.microsoft.com/office/drawing/2014/main" val="3086359738"/>
                    </a:ext>
                  </a:extLst>
                </a:gridCol>
                <a:gridCol w="1391911">
                  <a:extLst>
                    <a:ext uri="{9D8B030D-6E8A-4147-A177-3AD203B41FA5}">
                      <a16:colId xmlns:a16="http://schemas.microsoft.com/office/drawing/2014/main" val="2044282578"/>
                    </a:ext>
                  </a:extLst>
                </a:gridCol>
                <a:gridCol w="1232835">
                  <a:extLst>
                    <a:ext uri="{9D8B030D-6E8A-4147-A177-3AD203B41FA5}">
                      <a16:colId xmlns:a16="http://schemas.microsoft.com/office/drawing/2014/main" val="4035162644"/>
                    </a:ext>
                  </a:extLst>
                </a:gridCol>
                <a:gridCol w="1421738">
                  <a:extLst>
                    <a:ext uri="{9D8B030D-6E8A-4147-A177-3AD203B41FA5}">
                      <a16:colId xmlns:a16="http://schemas.microsoft.com/office/drawing/2014/main" val="771312458"/>
                    </a:ext>
                  </a:extLst>
                </a:gridCol>
              </a:tblGrid>
              <a:tr h="58772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coding region covered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coding region covered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coding region covered </a:t>
                      </a:r>
                    </a:p>
                  </a:txBody>
                  <a:tcPr marL="2907" marR="2907" marT="290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8275014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TA1 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O5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3GALNT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2.51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3366897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4GAT1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AG3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IN1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3049127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VES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PN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V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9402472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DC78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FL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KB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2266845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TN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12A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6A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1111555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6A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6A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CRYAB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056133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AG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S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3760150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NAJB6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NM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YSF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8799052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MD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HL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KRP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0001202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KTN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LNC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MPPB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5666546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NE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HNRNPA2B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HNRNPDL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9227315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SCU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SPD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TGA7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4879084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BTBD1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L40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KLHL4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1266872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MA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MP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LARGE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9069196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DB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MS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LMNA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554246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MOD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GF10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MTM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9391411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F6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MYH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H7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5138788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OT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B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1.12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BPN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9856569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EC 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GLUT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POMGNT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6160145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MGNT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MK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MT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039537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MT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RYR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.96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SEPN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3.72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632714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GCA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SGCB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GCD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2193584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GCG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SMCHD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SPEG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0222462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NE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NE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AP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974874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4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TMEM5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NT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2020663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PO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TOR1AIP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TPM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3174457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M3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APPC11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TRIM32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0858931"/>
                  </a:ext>
                </a:extLst>
              </a:tr>
              <a:tr h="19797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N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.66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CP 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2907" marR="2907" marT="290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70959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91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7</Words>
  <Application>Microsoft Office PowerPoint</Application>
  <PresentationFormat>Widescreen</PresentationFormat>
  <Paragraphs>1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2</cp:revision>
  <dcterms:created xsi:type="dcterms:W3CDTF">2020-01-14T07:41:46Z</dcterms:created>
  <dcterms:modified xsi:type="dcterms:W3CDTF">2020-01-14T07:43:52Z</dcterms:modified>
</cp:coreProperties>
</file>